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8"/>
  </p:notesMasterIdLst>
  <p:sldIdLst>
    <p:sldId id="259" r:id="rId2"/>
    <p:sldId id="260" r:id="rId3"/>
    <p:sldId id="261" r:id="rId4"/>
    <p:sldId id="257" r:id="rId5"/>
    <p:sldId id="256" r:id="rId6"/>
    <p:sldId id="258" r:id="rId7"/>
  </p:sldIdLst>
  <p:sldSz cx="6858000" cy="12193588"/>
  <p:notesSz cx="9144000" cy="6858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383" userDrawn="1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EB344D84-9AFB-497E-A393-DC336BA19D2E}" styleName="Medium Style 3 - Accent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85BE263C-DBD7-4A20-BB59-AAB30ACAA65A}" styleName="Medium Style 3 - Accent 2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978"/>
    <p:restoredTop sz="93924"/>
  </p:normalViewPr>
  <p:slideViewPr>
    <p:cSldViewPr snapToGrid="0" snapToObjects="1" showGuides="1">
      <p:cViewPr>
        <p:scale>
          <a:sx n="75" d="100"/>
          <a:sy n="75" d="100"/>
        </p:scale>
        <p:origin x="3318" y="54"/>
      </p:cViewPr>
      <p:guideLst>
        <p:guide orient="horz" pos="538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A9D055A-BC96-2247-B46A-46688824A0F1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921125" y="857250"/>
            <a:ext cx="130175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DACE2BF-79BD-8646-8BF0-087950D0EBD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686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CE2BF-79BD-8646-8BF0-087950D0EBD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770597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CE2BF-79BD-8646-8BF0-087950D0EBD1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49326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DACE2BF-79BD-8646-8BF0-087950D0EBD1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45805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572"/>
            <a:ext cx="5829300" cy="4245175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4457"/>
            <a:ext cx="5143500" cy="2943960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96"/>
            <a:ext cx="1478756" cy="1033350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96"/>
            <a:ext cx="4350544" cy="1033350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933"/>
            <a:ext cx="5915025" cy="507219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60111"/>
            <a:ext cx="5915025" cy="2667346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978"/>
            <a:ext cx="2914650" cy="77367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978"/>
            <a:ext cx="2914650" cy="773672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99"/>
            <a:ext cx="5915025" cy="23568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9124"/>
            <a:ext cx="2901255" cy="1464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4047"/>
            <a:ext cx="2901255" cy="65512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9124"/>
            <a:ext cx="2915543" cy="1464923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4047"/>
            <a:ext cx="2915543" cy="655123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906"/>
            <a:ext cx="2211884" cy="28451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653"/>
            <a:ext cx="3471863" cy="86653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8076"/>
            <a:ext cx="2211884" cy="677703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906"/>
            <a:ext cx="2211884" cy="2845171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653"/>
            <a:ext cx="3471863" cy="866535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8076"/>
            <a:ext cx="2211884" cy="6777039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99"/>
            <a:ext cx="5915025" cy="23568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978"/>
            <a:ext cx="5915025" cy="773672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1652"/>
            <a:ext cx="1543050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1BF4B8-216E-8144-A68C-326580C4DF59}" type="datetimeFigureOut">
              <a:rPr lang="en-US" smtClean="0"/>
              <a:t>10/30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1652"/>
            <a:ext cx="2314575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1652"/>
            <a:ext cx="1543050" cy="64919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516A3-E18A-DC46-9EB8-B87D5B3A24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1482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21443603"/>
              </p:ext>
            </p:extLst>
          </p:nvPr>
        </p:nvGraphicFramePr>
        <p:xfrm>
          <a:off x="116702" y="409779"/>
          <a:ext cx="6607969" cy="11411185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128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67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519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19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22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621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904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s (Phospholipids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7992">
                <a:tc rowSpan="2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-ornith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7-Hydroxyproge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595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nedione</a:t>
                      </a:r>
                    </a:p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pha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adipic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kern="1200" dirty="0" err="1">
                          <a:solidFill>
                            <a:schemeClr val="tx1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coster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7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7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l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ag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t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buty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hydroepiandroster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ymmetricdimethyl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Estradiol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eta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20: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stosterone</a:t>
                      </a:r>
                    </a:p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h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0: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egnenol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itrull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ig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crot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4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gester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reat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s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co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M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gluta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y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Fum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2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7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ime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Kynure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Non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1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-sulfoxid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hist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e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rnith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edi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4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utres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enoylcarnitine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arc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dien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1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oton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0:2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0: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2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au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4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hre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otaldimethyl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ans-Hydroxy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noylcarnitine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imethylamine N-oxid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yptopha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r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58191" y="116379"/>
            <a:ext cx="692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1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Panel of serum metabolites analyzed after data pre-processing steps (125 metabolites total).</a:t>
            </a:r>
          </a:p>
        </p:txBody>
      </p:sp>
    </p:spTree>
    <p:extLst>
      <p:ext uri="{BB962C8B-B14F-4D97-AF65-F5344CB8AC3E}">
        <p14:creationId xmlns:p14="http://schemas.microsoft.com/office/powerpoint/2010/main" val="20296658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59596534"/>
              </p:ext>
            </p:extLst>
          </p:nvPr>
        </p:nvGraphicFramePr>
        <p:xfrm>
          <a:off x="116702" y="376528"/>
          <a:ext cx="6607969" cy="11742711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128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67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519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19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22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621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904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s (Phospholipids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7992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7-Hydroxyproge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-ornithine</a:t>
                      </a: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nedi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kern="1200" dirty="0" err="1">
                          <a:solidFill>
                            <a:schemeClr val="tx1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l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ag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7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7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n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t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hydroepiandro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ymmetric dimethyl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buty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Est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eta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ge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0: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sto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h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itrull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ig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crot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reat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s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reat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etylsperm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M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gluta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2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cos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Fum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y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7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ime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Non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1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-Sulfoxid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e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hist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edi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rnith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1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enoylcarnitine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0:2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0: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utres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dien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arc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2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4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otoni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au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hre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otal dimethyl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noylcarnitine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ans-Hydroxy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imethylamine N-oxid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yptopha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r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r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58191" y="116379"/>
            <a:ext cx="692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2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Panel of urine metabolites analyzed after data pre-processing steps (123 metabolites total).</a:t>
            </a:r>
          </a:p>
        </p:txBody>
      </p:sp>
    </p:spTree>
    <p:extLst>
      <p:ext uri="{BB962C8B-B14F-4D97-AF65-F5344CB8AC3E}">
        <p14:creationId xmlns:p14="http://schemas.microsoft.com/office/powerpoint/2010/main" val="196384326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7311579"/>
              </p:ext>
            </p:extLst>
          </p:nvPr>
        </p:nvGraphicFramePr>
        <p:xfrm>
          <a:off x="158266" y="343277"/>
          <a:ext cx="6607969" cy="1149561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1128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64677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45193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1966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442224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6219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27904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s (Phospholipids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s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0799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</a:t>
                      </a:r>
                      <a:r>
                        <a:rPr lang="en-US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nam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nedi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pha-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adipic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id</a:t>
                      </a:r>
                    </a:p>
                  </a:txBody>
                  <a:tcPr marL="6350" marR="6350" marT="6350" marB="0" anchor="b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</a:p>
                  </a:txBody>
                  <a:tcPr marL="5189" marR="5189" marT="5189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l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>
                      <a:noFill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rg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hydroepiandro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ag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kern="1200" dirty="0" err="1">
                          <a:solidFill>
                            <a:schemeClr val="tx1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Est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t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7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7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ge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459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ymmetric </a:t>
                      </a:r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methylargi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propio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stosterone</a:t>
                      </a: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buty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itru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reati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3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20:3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c acid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0: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ig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crot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4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y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/ 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sac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M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glutar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41714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valeryl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 / -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buty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malo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Kynure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(</a:t>
                      </a:r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Fumar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2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eu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7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imel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0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6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-Sulfoxid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9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Non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rnith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1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ala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2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ethyla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A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utresc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eno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E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DC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edi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4:1</a:t>
                      </a:r>
                      <a:r>
                        <a:rPr lang="en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MOH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d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ru-RU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aur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enoylcarnitine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1</a:t>
                      </a:r>
                      <a:r>
                        <a:rPr lang="en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MOH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hreon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dienylcarnitine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0SM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0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ans-OH-Pro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1SM</a:t>
                      </a:r>
                    </a:p>
                    <a:p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18:1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yptophan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0:2SM</a:t>
                      </a:r>
                    </a:p>
                    <a:p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pt-BR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</a:t>
                      </a:r>
                      <a:r>
                        <a:rPr lang="pt-BR" sz="8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0:2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2768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ros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1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ine</a:t>
                      </a: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2SM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2:2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4:1</a:t>
                      </a:r>
                      <a:r>
                        <a:rPr lang="en-CA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MOH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noylcarnitine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280208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OH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octadeceno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2</a:t>
                      </a: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dirty="0" err="1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dienylcarnitine</a:t>
                      </a:r>
                      <a:r>
                        <a:rPr lang="en-US" sz="800" dirty="0"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165763"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/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6350" marR="6350" marT="6350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74816" y="74815"/>
            <a:ext cx="692450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3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Panel of saliva metabolites analyzed after data pre-processing steps (155 metabolites total).</a:t>
            </a:r>
          </a:p>
        </p:txBody>
      </p:sp>
    </p:spTree>
    <p:extLst>
      <p:ext uri="{BB962C8B-B14F-4D97-AF65-F5344CB8AC3E}">
        <p14:creationId xmlns:p14="http://schemas.microsoft.com/office/powerpoint/2010/main" val="163758411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02672940"/>
              </p:ext>
            </p:extLst>
          </p:nvPr>
        </p:nvGraphicFramePr>
        <p:xfrm>
          <a:off x="257695" y="413242"/>
          <a:ext cx="6248401" cy="917873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77193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771934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0151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01511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90151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p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-nam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-valu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og2(FC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</a:t>
                      </a:r>
                    </a:p>
                  </a:txBody>
                  <a:tcPr marL="2962" marR="2962" marT="2962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geste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45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75149</a:t>
                      </a: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7-Hydroxyprogeste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7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98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7.68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8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34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7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stoster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5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r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4E-08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54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hydroepiandroste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9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1103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reatin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8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143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2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9665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aur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4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366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Isoleuc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12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8196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ag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57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779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tic ac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91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238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59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26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al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9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45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-ornith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6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39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erotoni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8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375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ymmetric dimethylargin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63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4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otal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methylargi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15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877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d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8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24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85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9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arcos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8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uk-UA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953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etylsperm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30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3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eta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4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28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4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62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268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6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0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6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7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28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6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1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43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85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0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3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465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 C16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6:0SM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9.82E-10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700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46557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 C1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0SM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60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562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 C22: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2:1SM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91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886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24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4:1SM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00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49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2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2:2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0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8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6: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6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9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998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0AA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57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8615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40: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E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8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075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40: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A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3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69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1AA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3E-0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2419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48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85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01E-0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98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2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139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propion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O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00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72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igl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5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09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e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67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534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:1</a:t>
                      </a:r>
                      <a:endParaRPr lang="ru-RU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7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36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valerylcarnitine (Methylmalonylcarnitin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OH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39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13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con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DC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66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258874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rylcarnitine (Hydroxyhexanoylcarnitin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D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08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740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8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84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6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gluta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MDC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00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5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imel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7DC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9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636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6.53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494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:1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1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72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8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415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di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6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38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02E-08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597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adi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4E-02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59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9E-0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56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9478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32E-05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566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hexadecadi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3E-02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cs-CZ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12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173570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octadece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OH</a:t>
                      </a:r>
                      <a:endParaRPr lang="de-DE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31E-04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2962" marR="2962" marT="2962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21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813070" y="9592888"/>
            <a:ext cx="17620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aseline="30000" dirty="0">
                <a:latin typeface="Palatino Linotype" charset="0"/>
                <a:ea typeface="Palatino Linotype" charset="0"/>
                <a:cs typeface="Palatino Linotype" charset="0"/>
              </a:rPr>
              <a:t>1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FC = Fold change, 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HRPmean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/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INFmean</a:t>
            </a:r>
            <a:endParaRPr lang="en-US" sz="700" dirty="0">
              <a:latin typeface="Palatino Linotype" charset="0"/>
              <a:ea typeface="Palatino Linotype" charset="0"/>
              <a:cs typeface="Palatino Linotype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07818" y="0"/>
            <a:ext cx="629273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4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Urine metabolites found at significantly different (p&lt;0.05) concentrations between HRP and INF sows.</a:t>
            </a:r>
          </a:p>
        </p:txBody>
      </p:sp>
    </p:spTree>
    <p:extLst>
      <p:ext uri="{BB962C8B-B14F-4D97-AF65-F5344CB8AC3E}">
        <p14:creationId xmlns:p14="http://schemas.microsoft.com/office/powerpoint/2010/main" val="2376808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5495196"/>
              </p:ext>
            </p:extLst>
          </p:nvPr>
        </p:nvGraphicFramePr>
        <p:xfrm>
          <a:off x="169382" y="388753"/>
          <a:ext cx="6585736" cy="9949742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99392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81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9940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93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2482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p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-nam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-valu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og2(FC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</a:t>
                      </a:r>
                    </a:p>
                  </a:txBody>
                  <a:tcPr marL="728" marR="728" marT="728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geste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30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7291</a:t>
                      </a: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Estr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01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068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ortisol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6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733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stoster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endParaRPr lang="en-US" sz="80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8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955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ndrostenedio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teroid hormo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lang="en-US" sz="800" dirty="0"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41E-07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771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a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2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8798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ag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7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547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spartic ac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18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21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mic acid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9.51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9619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yc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23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20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7.39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4481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l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00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521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hreo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5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055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yptoph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98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61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ros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4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9904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 ornith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80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092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lpha-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adipic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id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10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270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os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3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35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Kynure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38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275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ionine-Sulfoxid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7.18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7447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d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70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859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erm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2E-1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7033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47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26114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6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41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20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6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6:1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2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183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7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7:0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55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12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0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5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29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7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18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1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28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34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8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11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60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9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0: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0:3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72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93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0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4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4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2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60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1"/>
                  </a:ext>
                </a:extLst>
              </a:tr>
              <a:tr h="274292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acyl C28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8:0</a:t>
                      </a:r>
                      <a:endParaRPr lang="tr-T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49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530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 C18: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i-FI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8:1SM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65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8195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phingomyeline C20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0:2SM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20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012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4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sphingomyeline C14: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de-DE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4:1SMOH</a:t>
                      </a:r>
                      <a:endParaRPr lang="de-DE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56E-05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8532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5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6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A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64E-1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59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6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36: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E</a:t>
                      </a:r>
                      <a:endParaRPr lang="pt-B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2E-1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58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7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6: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6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68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194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8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38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6AA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5.10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790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39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6AA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63E-1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59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0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</a:t>
                      </a:r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iacyl</a:t>
                      </a:r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 C40:1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1AA</a:t>
                      </a:r>
                      <a:endParaRPr lang="fr-F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6E-1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625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4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12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4573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4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propion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-OH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88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043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5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5677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4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en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:1</a:t>
                      </a:r>
                      <a:endParaRPr lang="ru-RU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92E-1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67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5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e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3E-03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30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6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rylcarnitine (Hydroxyhexanoylcarnitine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-DC (C6-OH)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77E-04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397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7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glutar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-M-DC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13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25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8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igl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09E-02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8244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49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utacon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5:1-DC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7E-02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768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0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77E-05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319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imel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7-DC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84E-0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25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8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7.34E-1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6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Nona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9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7.55E-11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3.2253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4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0:1</a:t>
                      </a:r>
                      <a:endParaRPr lang="ru-RU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9.30E-06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338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5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8.91E-10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973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6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anedi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-DC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36E-09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002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7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Do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2:1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8E-07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684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8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10E-18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61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59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tetra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1-OH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01E-02</a:t>
                      </a:r>
                      <a:endParaRPr lang="mr-IN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30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0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etradecadi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4:2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9E-10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169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1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1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2E-10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874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2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decadi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6:2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7E-02</a:t>
                      </a:r>
                      <a:endParaRPr lang="fi-FI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3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e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i-FI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40E-11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2.6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4"/>
                  </a:ext>
                </a:extLst>
              </a:tr>
              <a:tr h="189323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ydroxyoctadece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-OH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5E-0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825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5"/>
                  </a:ext>
                </a:extLst>
              </a:tr>
              <a:tr h="9502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adien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i-FI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2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2.24E-03</a:t>
                      </a:r>
                      <a:endParaRPr lang="mr-IN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728" marR="728" marT="728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fi-FI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3.1987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66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9752" y="0"/>
            <a:ext cx="662524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5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Saliva metabolites found at significantly different (p&lt;0.05) concentrations between HRP and INF sows.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029200" y="10390909"/>
            <a:ext cx="17620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aseline="30000" dirty="0">
                <a:latin typeface="Palatino Linotype" charset="0"/>
                <a:ea typeface="Palatino Linotype" charset="0"/>
                <a:cs typeface="Palatino Linotype" charset="0"/>
              </a:rPr>
              <a:t>1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FC = Fold change, 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HRPmean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/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INFmean</a:t>
            </a:r>
            <a:endParaRPr lang="en-US" sz="700" dirty="0">
              <a:latin typeface="Palatino Linotype" charset="0"/>
              <a:ea typeface="Palatino Linotype" charset="0"/>
              <a:cs typeface="Palatino Linotype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57350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1559218"/>
              </p:ext>
            </p:extLst>
          </p:nvPr>
        </p:nvGraphicFramePr>
        <p:xfrm>
          <a:off x="183400" y="396153"/>
          <a:ext cx="6357937" cy="3973753"/>
        </p:xfrm>
        <a:graphic>
          <a:graphicData uri="http://schemas.openxmlformats.org/drawingml/2006/table">
            <a:tbl>
              <a:tblPr>
                <a:tableStyleId>{9D7B26C5-4107-4FEC-AEDC-1716B250A1EF}</a:tableStyleId>
              </a:tblPr>
              <a:tblGrid>
                <a:gridCol w="18818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8189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8958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5228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65228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54925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abolit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yp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Short-name</a:t>
                      </a:r>
                      <a:endParaRPr lang="en-US" sz="800" b="1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-value</a:t>
                      </a:r>
                      <a:endParaRPr lang="en-US" sz="800" b="1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l" defTabSz="6858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og2(FC</a:t>
                      </a:r>
                      <a:r>
                        <a:rPr lang="en-US" sz="8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</a:t>
                      </a:r>
                      <a:r>
                        <a:rPr lang="en-US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)</a:t>
                      </a:r>
                    </a:p>
                  </a:txBody>
                  <a:tcPr marL="5189" marR="5189" marT="5189" marB="0" anchor="b">
                    <a:lnB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Glyc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9903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5843</a:t>
                      </a:r>
                    </a:p>
                  </a:txBody>
                  <a:tcPr marL="6350" marR="6350" marT="6350" marB="0" anchor="b">
                    <a:lnT w="12700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istam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000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857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Val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7295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13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utresc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8656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503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ans-Hydroxyprol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15645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3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enylalan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1695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628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cetyl-ornith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0004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4.066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Tryptophan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11892</a:t>
                      </a:r>
                      <a:endParaRPr lang="hr-HR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40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thylhistid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Amino acid or amino acid derivativ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0576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2425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4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4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46306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7753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18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18:2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21675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283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24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4:0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606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2.303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phosphatidylcholine acyl C26:1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tr-T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YSOC26:1</a:t>
                      </a:r>
                      <a:endParaRPr lang="tr-T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32453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4874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2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2:2AA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42419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548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acyl-alkyl C36:0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pt-B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6:0AE</a:t>
                      </a:r>
                      <a:endParaRPr lang="pt-B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35531</a:t>
                      </a:r>
                      <a:endParaRPr lang="nb-NO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738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38:6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r-FR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38:6AA</a:t>
                      </a:r>
                      <a:endParaRPr lang="fr-FR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t-IT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19558</a:t>
                      </a:r>
                      <a:endParaRPr lang="it-IT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2112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hosphatidylcholine diacyl C40:2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Membrane Lipid (Phospholipid)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C40:2AA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4239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84202</a:t>
                      </a:r>
                    </a:p>
                  </a:txBody>
                  <a:tcPr marL="6350" marR="6350" marT="6350" marB="0" anchor="b">
                    <a:lnB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L-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0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45912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80228</a:t>
                      </a:r>
                    </a:p>
                  </a:txBody>
                  <a:tcPr marL="6350" marR="6350" marT="6350" marB="0" anchor="b">
                    <a:lnT w="3175" cap="flat" cmpd="sng" algn="ctr">
                      <a:solidFill>
                        <a:schemeClr val="bg2">
                          <a:lumMod val="75000"/>
                        </a:schemeClr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enoyl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ru-RU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:1</a:t>
                      </a:r>
                      <a:endParaRPr lang="ru-RU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33992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1.5729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Propionyl 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3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3662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7291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Butyryl 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4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nb-NO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03399</a:t>
                      </a:r>
                      <a:endParaRPr lang="nb-NO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hr-HR" sz="800" b="0" i="0" u="none" strike="noStrike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1.306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Hexanoyl 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6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22083</a:t>
                      </a:r>
                      <a:endParaRPr lang="is-IS" sz="800" b="0" i="0" u="none" strike="noStrike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mr-IN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-0.90555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166036"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u="none" strike="noStrike" dirty="0" err="1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Octadecenoyl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U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arnitine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fi-FI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C18:1</a:t>
                      </a:r>
                      <a:endParaRPr lang="fi-FI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ctr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u="none" strike="noStrike" dirty="0"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026209</a:t>
                      </a:r>
                      <a:endParaRPr lang="is-IS" sz="800" b="0" i="0" u="none" strike="noStrike" dirty="0">
                        <a:solidFill>
                          <a:srgbClr val="000000"/>
                        </a:solidFill>
                        <a:effectLst/>
                        <a:latin typeface="Palatino Linotype" charset="0"/>
                        <a:ea typeface="Palatino Linotype" charset="0"/>
                        <a:cs typeface="Palatino Linotype" charset="0"/>
                      </a:endParaRPr>
                    </a:p>
                  </a:txBody>
                  <a:tcPr marL="5189" marR="5189" marT="5189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is-I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Palatino Linotype" charset="0"/>
                          <a:ea typeface="Palatino Linotype" charset="0"/>
                          <a:cs typeface="Palatino Linotype" charset="0"/>
                        </a:rPr>
                        <a:t>0.8006</a:t>
                      </a:r>
                    </a:p>
                  </a:txBody>
                  <a:tcPr marL="6350" marR="6350" marT="6350" marB="0" anchor="b"/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</a:tbl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4846319" y="4372247"/>
            <a:ext cx="1762021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700" baseline="30000" dirty="0">
                <a:latin typeface="Palatino Linotype" charset="0"/>
                <a:ea typeface="Palatino Linotype" charset="0"/>
                <a:cs typeface="Palatino Linotype" charset="0"/>
              </a:rPr>
              <a:t>1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FC = Fold change, 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HRPmean</a:t>
            </a:r>
            <a:r>
              <a:rPr lang="en-US" sz="700" dirty="0">
                <a:latin typeface="Palatino Linotype" charset="0"/>
                <a:ea typeface="Palatino Linotype" charset="0"/>
                <a:cs typeface="Palatino Linotype" charset="0"/>
              </a:rPr>
              <a:t>/</a:t>
            </a:r>
            <a:r>
              <a:rPr lang="en-US" sz="700" dirty="0" err="1">
                <a:latin typeface="Palatino Linotype" charset="0"/>
                <a:ea typeface="Palatino Linotype" charset="0"/>
                <a:cs typeface="Palatino Linotype" charset="0"/>
              </a:rPr>
              <a:t>INFmean</a:t>
            </a:r>
            <a:endParaRPr lang="en-US" sz="700" dirty="0">
              <a:latin typeface="Palatino Linotype" charset="0"/>
              <a:ea typeface="Palatino Linotype" charset="0"/>
              <a:cs typeface="Palatino Linotype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9753" y="0"/>
            <a:ext cx="65753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Palatino Linotype" charset="0"/>
                <a:ea typeface="Palatino Linotype" charset="0"/>
                <a:cs typeface="Palatino Linotype" charset="0"/>
              </a:rPr>
              <a:t>Supplementary Table S6</a:t>
            </a:r>
            <a:r>
              <a:rPr lang="en-US" sz="1000" dirty="0">
                <a:latin typeface="Palatino Linotype" charset="0"/>
                <a:ea typeface="Palatino Linotype" charset="0"/>
                <a:cs typeface="Palatino Linotype" charset="0"/>
              </a:rPr>
              <a:t>. Serum metabolites found at significantly different (p&lt;0.05) concentrations between HRP and INF sows.</a:t>
            </a:r>
          </a:p>
        </p:txBody>
      </p:sp>
    </p:spTree>
    <p:extLst>
      <p:ext uri="{BB962C8B-B14F-4D97-AF65-F5344CB8AC3E}">
        <p14:creationId xmlns:p14="http://schemas.microsoft.com/office/powerpoint/2010/main" val="3820591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9</TotalTime>
  <Words>2323</Words>
  <Application>Microsoft Office PowerPoint</Application>
  <PresentationFormat>Custom</PresentationFormat>
  <Paragraphs>1332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Palatino Linotype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uren Fletcher</dc:creator>
  <cp:lastModifiedBy>MDPI</cp:lastModifiedBy>
  <cp:revision>45</cp:revision>
  <cp:lastPrinted>2022-10-20T17:14:16Z</cp:lastPrinted>
  <dcterms:created xsi:type="dcterms:W3CDTF">2022-09-23T15:54:00Z</dcterms:created>
  <dcterms:modified xsi:type="dcterms:W3CDTF">2022-10-30T09:19:03Z</dcterms:modified>
</cp:coreProperties>
</file>